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mc="http://schemas.openxmlformats.org/markup-compatibility/2006" xmlns:mv="urn:schemas-microsoft-com:mac:vml"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mc="http://schemas.openxmlformats.org/markup-compatibility/2006" xmlns:mv="urn:schemas-microsoft-com:mac:vml" xmlns:p14="http://schemas.microsoft.com/office/powerpoint/2010/main" xmlns="" val="0"/>
    </p:ext>
    <p:ext uri="{D31A062A-798A-4329-ABDD-BBA856620510}">
      <p14:defaultImageDpi xmlns:mc="http://schemas.openxmlformats.org/markup-compatibility/2006" xmlns:mv="urn:schemas-microsoft-com:mac:vml" xmlns:p14="http://schemas.microsoft.com/office/powerpoint/2010/main" xmlns="" val="220"/>
    </p:ext>
    <p:ext uri="{FD5EFAAD-0ECE-453E-9831-46B23BE46B34}">
      <p15:chartTrackingRefBased xmlns:mc="http://schemas.openxmlformats.org/markup-compatibility/2006" xmlns:mv="urn:schemas-microsoft-com:mac:vml"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61" autoAdjust="0"/>
    <p:restoredTop sz="94660"/>
  </p:normalViewPr>
  <p:slideViewPr>
    <p:cSldViewPr snapToGrid="0">
      <p:cViewPr varScale="1">
        <p:scale>
          <a:sx n="60" d="100"/>
          <a:sy n="60" d="100"/>
        </p:scale>
        <p:origin x="-876" y="-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12" indent="0" algn="ctr">
              <a:buNone/>
              <a:defRPr sz="2000"/>
            </a:lvl2pPr>
            <a:lvl3pPr marL="914423" indent="0" algn="ctr">
              <a:buNone/>
              <a:defRPr sz="1801"/>
            </a:lvl3pPr>
            <a:lvl4pPr marL="1371634" indent="0" algn="ctr">
              <a:buNone/>
              <a:defRPr sz="1600"/>
            </a:lvl4pPr>
            <a:lvl5pPr marL="1828846" indent="0" algn="ctr">
              <a:buNone/>
              <a:defRPr sz="1600"/>
            </a:lvl5pPr>
            <a:lvl6pPr marL="2286057" indent="0" algn="ctr">
              <a:buNone/>
              <a:defRPr sz="1600"/>
            </a:lvl6pPr>
            <a:lvl7pPr marL="2743268" indent="0" algn="ctr">
              <a:buNone/>
              <a:defRPr sz="1600"/>
            </a:lvl7pPr>
            <a:lvl8pPr marL="3200480" indent="0" algn="ctr">
              <a:buNone/>
              <a:defRPr sz="1600"/>
            </a:lvl8pPr>
            <a:lvl9pPr marL="3657692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9112C-6B8D-4470-8D75-F19BD64293AE}" type="datetimeFigureOut">
              <a:rPr lang="ko-KR" altLang="en-US" smtClean="0"/>
              <a:pPr/>
              <a:t>2017-06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2E8F9-999A-4D3E-AFCE-6F45940D630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3239279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9112C-6B8D-4470-8D75-F19BD64293AE}" type="datetimeFigureOut">
              <a:rPr lang="ko-KR" altLang="en-US" smtClean="0"/>
              <a:pPr/>
              <a:t>2017-06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2E8F9-999A-4D3E-AFCE-6F45940D630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4017669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9112C-6B8D-4470-8D75-F19BD64293AE}" type="datetimeFigureOut">
              <a:rPr lang="ko-KR" altLang="en-US" smtClean="0"/>
              <a:pPr/>
              <a:t>2017-06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2E8F9-999A-4D3E-AFCE-6F45940D630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2724037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9112C-6B8D-4470-8D75-F19BD64293AE}" type="datetimeFigureOut">
              <a:rPr lang="ko-KR" altLang="en-US" smtClean="0"/>
              <a:pPr/>
              <a:t>2017-06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2E8F9-999A-4D3E-AFCE-6F45940D630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1087788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3" y="1709742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3" y="4589467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1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23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5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6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8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9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9112C-6B8D-4470-8D75-F19BD64293AE}" type="datetimeFigureOut">
              <a:rPr lang="ko-KR" altLang="en-US" smtClean="0"/>
              <a:pPr/>
              <a:t>2017-06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2E8F9-999A-4D3E-AFCE-6F45940D630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17917127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9112C-6B8D-4470-8D75-F19BD64293AE}" type="datetimeFigureOut">
              <a:rPr lang="ko-KR" altLang="en-US" smtClean="0"/>
              <a:pPr/>
              <a:t>2017-06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2E8F9-999A-4D3E-AFCE-6F45940D630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2376145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9" y="365129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93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2" indent="0">
              <a:buNone/>
              <a:defRPr sz="2000" b="1"/>
            </a:lvl2pPr>
            <a:lvl3pPr marL="914423" indent="0">
              <a:buNone/>
              <a:defRPr sz="1801" b="1"/>
            </a:lvl3pPr>
            <a:lvl4pPr marL="1371634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0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93" y="2505076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3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2" indent="0">
              <a:buNone/>
              <a:defRPr sz="2000" b="1"/>
            </a:lvl2pPr>
            <a:lvl3pPr marL="914423" indent="0">
              <a:buNone/>
              <a:defRPr sz="1801" b="1"/>
            </a:lvl3pPr>
            <a:lvl4pPr marL="1371634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0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3" y="2505076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9112C-6B8D-4470-8D75-F19BD64293AE}" type="datetimeFigureOut">
              <a:rPr lang="ko-KR" altLang="en-US" smtClean="0"/>
              <a:pPr/>
              <a:t>2017-06-1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2E8F9-999A-4D3E-AFCE-6F45940D630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24854184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9112C-6B8D-4470-8D75-F19BD64293AE}" type="datetimeFigureOut">
              <a:rPr lang="ko-KR" altLang="en-US" smtClean="0"/>
              <a:pPr/>
              <a:t>2017-06-1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2E8F9-999A-4D3E-AFCE-6F45940D630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1456417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9112C-6B8D-4470-8D75-F19BD64293AE}" type="datetimeFigureOut">
              <a:rPr lang="ko-KR" altLang="en-US" smtClean="0"/>
              <a:pPr/>
              <a:t>2017-06-1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2E8F9-999A-4D3E-AFCE-6F45940D630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32087758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90" y="987429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2" indent="0">
              <a:buNone/>
              <a:defRPr sz="1401"/>
            </a:lvl2pPr>
            <a:lvl3pPr marL="914423" indent="0">
              <a:buNone/>
              <a:defRPr sz="1200"/>
            </a:lvl3pPr>
            <a:lvl4pPr marL="1371634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0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9112C-6B8D-4470-8D75-F19BD64293AE}" type="datetimeFigureOut">
              <a:rPr lang="ko-KR" altLang="en-US" smtClean="0"/>
              <a:pPr/>
              <a:t>2017-06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2E8F9-999A-4D3E-AFCE-6F45940D630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1340832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90" y="987429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12" indent="0">
              <a:buNone/>
              <a:defRPr sz="2800"/>
            </a:lvl2pPr>
            <a:lvl3pPr marL="914423" indent="0">
              <a:buNone/>
              <a:defRPr sz="2400"/>
            </a:lvl3pPr>
            <a:lvl4pPr marL="1371634" indent="0">
              <a:buNone/>
              <a:defRPr sz="2000"/>
            </a:lvl4pPr>
            <a:lvl5pPr marL="1828846" indent="0">
              <a:buNone/>
              <a:defRPr sz="2000"/>
            </a:lvl5pPr>
            <a:lvl6pPr marL="2286057" indent="0">
              <a:buNone/>
              <a:defRPr sz="2000"/>
            </a:lvl6pPr>
            <a:lvl7pPr marL="2743268" indent="0">
              <a:buNone/>
              <a:defRPr sz="2000"/>
            </a:lvl7pPr>
            <a:lvl8pPr marL="3200480" indent="0">
              <a:buNone/>
              <a:defRPr sz="2000"/>
            </a:lvl8pPr>
            <a:lvl9pPr marL="3657692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2" indent="0">
              <a:buNone/>
              <a:defRPr sz="1401"/>
            </a:lvl2pPr>
            <a:lvl3pPr marL="914423" indent="0">
              <a:buNone/>
              <a:defRPr sz="1200"/>
            </a:lvl3pPr>
            <a:lvl4pPr marL="1371634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0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9112C-6B8D-4470-8D75-F19BD64293AE}" type="datetimeFigureOut">
              <a:rPr lang="ko-KR" altLang="en-US" smtClean="0"/>
              <a:pPr/>
              <a:t>2017-06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2E8F9-999A-4D3E-AFCE-6F45940D630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1810205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4" y="365129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4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1" y="635635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D9112C-6B8D-4470-8D75-F19BD64293AE}" type="datetimeFigureOut">
              <a:rPr lang="ko-KR" altLang="en-US" smtClean="0"/>
              <a:pPr/>
              <a:t>2017-06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4" y="6356354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1" y="635635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12E8F9-999A-4D3E-AFCE-6F45940D630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610444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23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7" indent="-228607" algn="l" defTabSz="914423" rtl="0" eaLnBrk="1" latinLnBrk="1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17" indent="-228607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29" indent="-228607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41" indent="-228607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53" indent="-228607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64" indent="-228607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75" indent="-228607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87" indent="-228607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97" indent="-228607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23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12" algn="l" defTabSz="914423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23" algn="l" defTabSz="914423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34" algn="l" defTabSz="914423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46" algn="l" defTabSz="914423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57" algn="l" defTabSz="914423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8" algn="l" defTabSz="914423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80" algn="l" defTabSz="914423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92" algn="l" defTabSz="914423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8943" y="180306"/>
            <a:ext cx="943813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1" dirty="0" smtClean="0"/>
              <a:t>S1 Fig</a:t>
            </a:r>
            <a:endParaRPr lang="ko-KR" altLang="en-US" sz="1801" dirty="0"/>
          </a:p>
        </p:txBody>
      </p:sp>
      <p:grpSp>
        <p:nvGrpSpPr>
          <p:cNvPr id="4" name="그룹 3"/>
          <p:cNvGrpSpPr/>
          <p:nvPr/>
        </p:nvGrpSpPr>
        <p:grpSpPr>
          <a:xfrm>
            <a:off x="2454733" y="39365"/>
            <a:ext cx="4735052" cy="2046256"/>
            <a:chOff x="2880760" y="1514175"/>
            <a:chExt cx="4735052" cy="2046256"/>
          </a:xfrm>
        </p:grpSpPr>
        <p:sp>
          <p:nvSpPr>
            <p:cNvPr id="7" name="타원 6"/>
            <p:cNvSpPr/>
            <p:nvPr/>
          </p:nvSpPr>
          <p:spPr>
            <a:xfrm>
              <a:off x="4377921" y="2300808"/>
              <a:ext cx="1144798" cy="1144798"/>
            </a:xfrm>
            <a:prstGeom prst="ellipse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801"/>
            </a:p>
          </p:txBody>
        </p:sp>
        <p:sp>
          <p:nvSpPr>
            <p:cNvPr id="8" name="타원 7"/>
            <p:cNvSpPr/>
            <p:nvPr/>
          </p:nvSpPr>
          <p:spPr>
            <a:xfrm>
              <a:off x="4950320" y="2105984"/>
              <a:ext cx="1461154" cy="1454447"/>
            </a:xfrm>
            <a:prstGeom prst="ellipse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801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677666" y="2676047"/>
              <a:ext cx="1558345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1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0</a:t>
              </a:r>
              <a:endParaRPr lang="ko-KR" altLang="en-US" sz="1401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048840" y="2679652"/>
              <a:ext cx="1034069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1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98</a:t>
              </a:r>
              <a:endParaRPr lang="ko-KR" altLang="en-US" sz="1401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532868" y="2678451"/>
              <a:ext cx="801481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1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43</a:t>
              </a:r>
              <a:endParaRPr lang="ko-KR" altLang="en-US" sz="1401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880760" y="1514175"/>
              <a:ext cx="2328898" cy="5234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1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</a:t>
              </a:r>
              <a:r>
                <a:rPr lang="en-US" altLang="ko-KR" sz="1401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LC</a:t>
              </a:r>
              <a:r>
                <a:rPr lang="en-US" altLang="ko-KR" sz="1401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Q-IMS-TOF</a:t>
              </a:r>
              <a:r>
                <a:rPr lang="en-US" altLang="ko-KR" sz="1401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  <a:p>
              <a:pPr algn="ctr"/>
              <a:r>
                <a:rPr lang="en-US" altLang="ko-KR" sz="1401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tform </a:t>
              </a:r>
              <a:r>
                <a:rPr lang="en-US" altLang="ko-KR" sz="1401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141)</a:t>
              </a:r>
              <a:endParaRPr lang="ko-KR" altLang="en-US" sz="1401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565873" y="1514175"/>
              <a:ext cx="2049939" cy="5234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1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</a:t>
              </a:r>
              <a:r>
                <a:rPr lang="en-US" altLang="ko-KR" sz="1401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LC-Q-orbitrap</a:t>
              </a:r>
              <a:r>
                <a:rPr lang="en-US" altLang="ko-KR" sz="1401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  <a:p>
              <a:pPr algn="ctr"/>
              <a:r>
                <a:rPr lang="en-US" altLang="ko-KR" sz="1401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tform </a:t>
              </a:r>
              <a:r>
                <a:rPr lang="en-US" altLang="ko-KR" sz="1401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altLang="ko-KR" sz="1401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8)</a:t>
              </a:r>
              <a:endParaRPr lang="ko-KR" altLang="en-US" sz="1401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" name="그룹 13"/>
          <p:cNvGrpSpPr/>
          <p:nvPr/>
        </p:nvGrpSpPr>
        <p:grpSpPr>
          <a:xfrm>
            <a:off x="2454733" y="2254068"/>
            <a:ext cx="4735052" cy="2046256"/>
            <a:chOff x="2880760" y="1514175"/>
            <a:chExt cx="4735052" cy="2046256"/>
          </a:xfrm>
        </p:grpSpPr>
        <p:sp>
          <p:nvSpPr>
            <p:cNvPr id="15" name="타원 14"/>
            <p:cNvSpPr/>
            <p:nvPr/>
          </p:nvSpPr>
          <p:spPr>
            <a:xfrm>
              <a:off x="4377921" y="2300808"/>
              <a:ext cx="1144798" cy="1144798"/>
            </a:xfrm>
            <a:prstGeom prst="ellipse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801"/>
            </a:p>
          </p:txBody>
        </p:sp>
        <p:sp>
          <p:nvSpPr>
            <p:cNvPr id="16" name="타원 15"/>
            <p:cNvSpPr/>
            <p:nvPr/>
          </p:nvSpPr>
          <p:spPr>
            <a:xfrm>
              <a:off x="4950320" y="2105984"/>
              <a:ext cx="1461154" cy="1454447"/>
            </a:xfrm>
            <a:prstGeom prst="ellipse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801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677666" y="2676047"/>
              <a:ext cx="1558345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1" b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ko-KR" altLang="en-US" sz="1401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048840" y="2679652"/>
              <a:ext cx="1034069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1" b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7</a:t>
              </a:r>
              <a:endParaRPr lang="ko-KR" altLang="en-US" sz="1401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532868" y="2678451"/>
              <a:ext cx="801481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1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33</a:t>
              </a:r>
              <a:endParaRPr lang="ko-KR" altLang="en-US" sz="1401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880760" y="1514175"/>
              <a:ext cx="2328898" cy="5234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1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</a:t>
              </a:r>
              <a:r>
                <a:rPr lang="en-US" altLang="ko-KR" sz="1401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LC</a:t>
              </a:r>
              <a:r>
                <a:rPr lang="en-US" altLang="ko-KR" sz="1401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Q-IMS-TOF</a:t>
              </a:r>
              <a:r>
                <a:rPr lang="en-US" altLang="ko-KR" sz="1401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  <a:p>
              <a:pPr algn="ctr"/>
              <a:r>
                <a:rPr lang="en-US" altLang="ko-KR" sz="1401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tform </a:t>
              </a:r>
              <a:r>
                <a:rPr lang="en-US" altLang="ko-KR" sz="1401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altLang="ko-KR" sz="1401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)</a:t>
              </a:r>
              <a:endParaRPr lang="ko-KR" altLang="en-US" sz="1401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565873" y="1514175"/>
              <a:ext cx="2049939" cy="5234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1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</a:t>
              </a:r>
              <a:r>
                <a:rPr lang="en-US" altLang="ko-KR" sz="1401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LC-Q-orbitrap</a:t>
              </a:r>
              <a:r>
                <a:rPr lang="en-US" altLang="ko-KR" sz="1401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  <a:p>
              <a:pPr algn="ctr"/>
              <a:r>
                <a:rPr lang="en-US" altLang="ko-KR" sz="1401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tform </a:t>
              </a:r>
              <a:r>
                <a:rPr lang="en-US" altLang="ko-KR" sz="1401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147)</a:t>
              </a:r>
              <a:endParaRPr lang="ko-KR" altLang="en-US" sz="1401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2" name="그룹 21"/>
          <p:cNvGrpSpPr/>
          <p:nvPr/>
        </p:nvGrpSpPr>
        <p:grpSpPr>
          <a:xfrm>
            <a:off x="2540796" y="4447400"/>
            <a:ext cx="4735052" cy="2046256"/>
            <a:chOff x="2880760" y="1514175"/>
            <a:chExt cx="4735052" cy="2046256"/>
          </a:xfrm>
        </p:grpSpPr>
        <p:sp>
          <p:nvSpPr>
            <p:cNvPr id="23" name="타원 22"/>
            <p:cNvSpPr/>
            <p:nvPr/>
          </p:nvSpPr>
          <p:spPr>
            <a:xfrm>
              <a:off x="4377921" y="2300808"/>
              <a:ext cx="1144798" cy="1144798"/>
            </a:xfrm>
            <a:prstGeom prst="ellipse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801"/>
            </a:p>
          </p:txBody>
        </p:sp>
        <p:sp>
          <p:nvSpPr>
            <p:cNvPr id="24" name="타원 23"/>
            <p:cNvSpPr/>
            <p:nvPr/>
          </p:nvSpPr>
          <p:spPr>
            <a:xfrm>
              <a:off x="4950320" y="2105984"/>
              <a:ext cx="1461154" cy="1454447"/>
            </a:xfrm>
            <a:prstGeom prst="ellipse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801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677666" y="2676047"/>
              <a:ext cx="1558345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1" b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lang="ko-KR" altLang="en-US" sz="1401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048840" y="2679652"/>
              <a:ext cx="1034069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1" b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ko-KR" altLang="en-US" sz="1401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576717" y="2719318"/>
              <a:ext cx="801481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1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ko-KR" altLang="en-US" sz="1401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880760" y="1514175"/>
              <a:ext cx="2328898" cy="5234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1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</a:t>
              </a:r>
              <a:r>
                <a:rPr lang="en-US" altLang="ko-KR" sz="1401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LC</a:t>
              </a:r>
              <a:r>
                <a:rPr lang="en-US" altLang="ko-KR" sz="1401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Q-IMS-TOF</a:t>
              </a:r>
              <a:r>
                <a:rPr lang="en-US" altLang="ko-KR" sz="1401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  <a:p>
              <a:pPr algn="ctr"/>
              <a:r>
                <a:rPr lang="en-US" altLang="ko-KR" sz="1401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tform </a:t>
              </a:r>
              <a:r>
                <a:rPr lang="en-US" altLang="ko-KR" sz="1401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altLang="ko-KR" sz="1401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)</a:t>
              </a:r>
              <a:endParaRPr lang="ko-KR" altLang="en-US" sz="1401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565873" y="1514175"/>
              <a:ext cx="2049939" cy="5234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1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</a:t>
              </a:r>
              <a:r>
                <a:rPr lang="en-US" altLang="ko-KR" sz="1401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LC-Q-orbitrap</a:t>
              </a:r>
              <a:r>
                <a:rPr lang="en-US" altLang="ko-KR" sz="1401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  <a:p>
              <a:pPr algn="ctr"/>
              <a:r>
                <a:rPr lang="en-US" altLang="ko-KR" sz="1401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tform (29)</a:t>
              </a:r>
              <a:endParaRPr lang="ko-KR" altLang="en-US" sz="1401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1813432" y="42882"/>
            <a:ext cx="7273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1" b="1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endParaRPr lang="ko-KR" altLang="en-US" sz="1801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813432" y="2254068"/>
            <a:ext cx="7273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1" b="1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endParaRPr lang="ko-KR" altLang="en-US" sz="1801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813432" y="4447400"/>
            <a:ext cx="7273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1" b="1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endParaRPr lang="ko-KR" altLang="en-US" sz="1801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8102009" y="562842"/>
            <a:ext cx="35300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mtClean="0"/>
              <a:t>Total protein identified</a:t>
            </a:r>
            <a:endParaRPr lang="ko-KR" altLang="en-US"/>
          </a:p>
        </p:txBody>
      </p:sp>
      <p:sp>
        <p:nvSpPr>
          <p:cNvPr id="33" name="TextBox 32"/>
          <p:cNvSpPr txBox="1"/>
          <p:nvPr/>
        </p:nvSpPr>
        <p:spPr>
          <a:xfrm>
            <a:off x="8102009" y="2331140"/>
            <a:ext cx="353001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mtClean="0"/>
              <a:t>Proteins which belong to the </a:t>
            </a:r>
          </a:p>
          <a:p>
            <a:r>
              <a:rPr lang="en-US" altLang="ko-KR" smtClean="0"/>
              <a:t>Korean whole saliva proteome</a:t>
            </a:r>
            <a:endParaRPr lang="ko-KR" altLang="en-US" dirty="0"/>
          </a:p>
        </p:txBody>
      </p:sp>
      <p:sp>
        <p:nvSpPr>
          <p:cNvPr id="34" name="TextBox 33"/>
          <p:cNvSpPr txBox="1"/>
          <p:nvPr/>
        </p:nvSpPr>
        <p:spPr>
          <a:xfrm>
            <a:off x="8102009" y="4300324"/>
            <a:ext cx="399784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mtClean="0"/>
              <a:t>Proteins which belong to the distinct Korean whole saliva proteins</a:t>
            </a:r>
            <a:endParaRPr lang="ko-KR" alt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25341593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5</TotalTime>
  <Words>75</Words>
  <Application>Microsoft Office PowerPoint</Application>
  <PresentationFormat>사용자 지정</PresentationFormat>
  <Paragraphs>29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ara_</dc:creator>
  <cp:lastModifiedBy>Yong &amp; Moon</cp:lastModifiedBy>
  <cp:revision>36</cp:revision>
  <dcterms:created xsi:type="dcterms:W3CDTF">2017-06-16T13:55:31Z</dcterms:created>
  <dcterms:modified xsi:type="dcterms:W3CDTF">2017-06-17T09:20:36Z</dcterms:modified>
</cp:coreProperties>
</file>